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5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32392E1-59BE-48AA-ADC6-4BF3ACF64B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1DF9E4E-550F-45FB-9CA4-CFB2929214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C039CAF-12A7-4CAC-B489-96C1004EB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BAC6279-FFEE-4428-8BB2-A59BB2E55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B061E4C-2474-4173-8000-69C87AE7B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16085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2AB888-00DF-4636-A4C2-292D68438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043D295-B235-4024-B37F-E56805F2A0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B0F013-DA7B-400F-BD99-853710229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F2F18A0-9322-40BC-B0A8-C24F08078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BBCF6A-28AE-4075-89CF-DA23DF5F4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7245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2C4D1B0-6528-4179-BABB-9E6E1F5F91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4D65888-753E-4C9F-BDCF-1DFEF1799E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912AB9-2393-48F8-9F8B-65B21B5E1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F575D5F-8909-4C49-9800-E21AF7797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7DC2DE-BC15-463C-81BA-C7FC1CCAE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60484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CF816D-AF51-4C12-94A9-5DB5FCA0F7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1AB9B06-0215-4C73-B36B-102C367D19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55B90F4-67EB-4985-A782-E46395BCD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77353B1-C31E-4A67-AB5D-80E675DF7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7FD3C64-9DC9-4094-9D42-0B5782ED9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3192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D28AF9-3F41-4496-9483-4128AD11C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B6C5219-623B-4AEA-A0CB-4B1A0649B9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EDE0210-D1C9-44CA-9A6B-66C3401DC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7B2453-7E6A-4CCA-8094-D5BD493C0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9C34B96-73C4-431E-BD4A-DBEB57BF0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69249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A14008-D076-4E64-AD2F-6A1110D34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BA5051F-192C-4399-91FE-46428D0782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CBAB1DE-963B-454E-8EBD-715351B482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17360A3-E781-4F81-A6FC-89C678685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037693B-1E80-4B50-ABF0-0D59FD8AB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1F608E6-418B-43D1-B524-1B11C5DD2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37265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A52765-1C0A-4D63-9781-C5FCE2FB7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8514524-EA4E-48A5-AA5E-A73A07493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1C276D3-9083-4616-A484-1BA7B0F2A7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891E483-F594-4A75-9D15-287AB60BDC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BD99682-3930-4E3E-80D7-2DE88EC685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42BE6CE-B887-4693-BC1E-E4D6B9B90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51FE7AF-305F-4A5C-9980-FF755E336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A4945D9-52AA-4CC5-8CCB-8DE9F78E8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8448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F736CC-D1AB-4A58-8192-C2117DCCF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D319B25-9853-4B03-9088-BC16CDE25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5E8089F-DC26-4F39-918C-13A95B3FD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31FA7D3-8A0C-4E3A-9A87-FC95D32DE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38220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55F6AAD-6477-4121-86FB-CA10E6112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77603CC-0245-45EF-B173-54AC44C8E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F20341D-AC7A-40F8-AA84-8B97126FE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5757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E6E26D-3969-4716-9179-FC875FEC7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3F3ED51-F0DB-4751-8F23-30E27664DD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11E4C13-C754-4059-B0C7-015F3E67C1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8ABA16-27FD-45C8-A29F-A0565F2F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3BBDB5A-E71B-4004-B874-F07008F5D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9000020-FD7F-4CAD-8178-DC90B2A29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27730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36C4ED-5F60-43A8-B948-A30675BE6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5CC5C29-96A1-4EE9-BBB6-410C823EBB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19FB930-70AC-4B33-993C-2B1BEF6FB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6F7BB92-BDA4-4AD5-9677-9B2B799A0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2AAC1D9-00FE-4782-BD82-8531EC03B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71FA47-2102-4D7C-9926-B7D7BF021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90749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D40AD61-8A95-447E-9D97-69674FE22E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6F70885-D28D-4036-AAD1-C1033CE4FA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48AEFAA-35AB-4321-A546-028862AD7A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CAD796-BFC2-409B-9AFA-44302F40FB15}" type="datetimeFigureOut">
              <a:rPr lang="fr-CH" smtClean="0"/>
              <a:t>26.04.2022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73FF9A8-A939-4DAA-B2E2-D9F4397BD0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FD010F2-EEB7-492C-9C49-59296EEBE6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08805-673B-443B-AF96-B7F0B81B2E85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30267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349DB9C4-6D5C-444A-9647-2596CBE8E6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4170631"/>
              </p:ext>
            </p:extLst>
          </p:nvPr>
        </p:nvGraphicFramePr>
        <p:xfrm>
          <a:off x="3609358" y="764882"/>
          <a:ext cx="4622165" cy="1352515"/>
        </p:xfrm>
        <a:graphic>
          <a:graphicData uri="http://schemas.openxmlformats.org/drawingml/2006/table">
            <a:tbl>
              <a:tblPr firstRow="1" firstCol="1" bandRow="1"/>
              <a:tblGrid>
                <a:gridCol w="2310765">
                  <a:extLst>
                    <a:ext uri="{9D8B030D-6E8A-4147-A177-3AD203B41FA5}">
                      <a16:colId xmlns:a16="http://schemas.microsoft.com/office/drawing/2014/main" val="3605415479"/>
                    </a:ext>
                  </a:extLst>
                </a:gridCol>
                <a:gridCol w="2311400">
                  <a:extLst>
                    <a:ext uri="{9D8B030D-6E8A-4147-A177-3AD203B41FA5}">
                      <a16:colId xmlns:a16="http://schemas.microsoft.com/office/drawing/2014/main" val="306002898"/>
                    </a:ext>
                  </a:extLst>
                </a:gridCol>
              </a:tblGrid>
              <a:tr h="230505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revalence of drug use among a random sample of drivers</a:t>
                      </a:r>
                      <a:endParaRPr lang="fr-CH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9425298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anada (2008) </a:t>
                      </a:r>
                      <a:r>
                        <a:rPr lang="en-GB" sz="1200" b="0" i="0" u="none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[1]</a:t>
                      </a:r>
                      <a:endParaRPr lang="fr-CH" sz="1200" b="0" i="0" u="none" baseline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0.4 %</a:t>
                      </a:r>
                      <a:endParaRPr lang="fr-CH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7646710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SA (2007) </a:t>
                      </a:r>
                      <a:r>
                        <a:rPr lang="en-GB" sz="1200" b="0" i="0" u="none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[2]</a:t>
                      </a:r>
                      <a:endParaRPr lang="fr-CH" sz="1200" b="0" i="0" u="none" baseline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3.6 %</a:t>
                      </a:r>
                      <a:endParaRPr lang="fr-CH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655940"/>
                  </a:ext>
                </a:extLst>
              </a:tr>
              <a:tr h="2368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rway (2008-2009) </a:t>
                      </a:r>
                      <a:r>
                        <a:rPr lang="en-GB" sz="1200" b="0" i="0" u="none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[3]</a:t>
                      </a: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endParaRPr lang="fr-CH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.3 %</a:t>
                      </a:r>
                      <a:endParaRPr lang="fr-CH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9120976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CH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rway</a:t>
                      </a:r>
                      <a:r>
                        <a:rPr lang="fr-CH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(2016-2017) </a:t>
                      </a:r>
                      <a:r>
                        <a:rPr lang="fr-CH" sz="1200" b="0" i="0" u="none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[4]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CH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.1 %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8546899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CH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pain (2015) </a:t>
                      </a:r>
                      <a:r>
                        <a:rPr lang="fr-CH" sz="1200" b="0" i="0" u="none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[5]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CH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.7 %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4234008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E35432F-068D-4749-A3F1-83BA04F16DB7}"/>
              </a:ext>
            </a:extLst>
          </p:cNvPr>
          <p:cNvSpPr/>
          <p:nvPr/>
        </p:nvSpPr>
        <p:spPr>
          <a:xfrm>
            <a:off x="40641" y="2365393"/>
            <a:ext cx="1175960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[1] D.J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Beirnes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E.E. Beasley, A roadside survey of alcohol and drug use among drivers in British Columbia, Traffic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nj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rev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11 (2010) 215-221.</a:t>
            </a:r>
            <a:endParaRPr lang="fr-CH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[2] T.K.-B. John H. Lacey, Debra Furr-Holden, Robert B. , E.R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Voa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Anthony Ramirez, Katharine Brainard, , P.T. Christine Moore, and Amy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Bernin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2007 National Roadside Survey of Alcohol and Drug Use by Drivers: Drug Results, in: N.H.T.S. Administration (Ed.), Pacific Institute for Research and Evaluation 2009.</a:t>
            </a:r>
            <a:endParaRPr lang="fr-CH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[3] H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jerd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A.S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hristopherse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P.T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orman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T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ssu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E.L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Oiesta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J. Morland, Norwegian roadside survey of alcohol and drug use by drivers (2008-2009), Traffic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nj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rev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14 (2013) 443-452.</a:t>
            </a:r>
            <a:endParaRPr lang="fr-CH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[4] H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Furuhauge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R.E.G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Ja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G. Nilsson, V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Vindene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H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jerd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Roadside survey of alcohol and drug use among Norwegian drivers in 2016-2017: A follow-up of the 2008-2009 survey, Traffic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nj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rev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19 (2018) 555-562.</a:t>
            </a:r>
            <a:endParaRPr lang="fr-CH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[5] A. Domingo-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Salvany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M.J. Herrero, B. Fernandez, J. Perez, P. Del Real, J.C. Gonzalez-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Luqu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R. de la Torre, Prevalence of psychoactive substances, alcohol and illicit drugs, in Spanish drivers: A roadside study in 2015, Forensic Sci Int, 278 (2017) 253-259.</a:t>
            </a:r>
            <a:endParaRPr lang="fr-CH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6" name="Titre 1">
            <a:extLst>
              <a:ext uri="{FF2B5EF4-FFF2-40B4-BE49-F238E27FC236}">
                <a16:creationId xmlns:a16="http://schemas.microsoft.com/office/drawing/2014/main" id="{FCD1BB96-F0DE-45A4-A8D0-540C86A9D821}"/>
              </a:ext>
            </a:extLst>
          </p:cNvPr>
          <p:cNvSpPr txBox="1">
            <a:spLocks/>
          </p:cNvSpPr>
          <p:nvPr/>
        </p:nvSpPr>
        <p:spPr>
          <a:xfrm>
            <a:off x="310478" y="211680"/>
            <a:ext cx="10530241" cy="33696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2: </a:t>
            </a:r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ious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domly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led</a:t>
            </a:r>
            <a:r>
              <a: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rivers</a:t>
            </a:r>
          </a:p>
        </p:txBody>
      </p:sp>
    </p:spTree>
    <p:extLst>
      <p:ext uri="{BB962C8B-B14F-4D97-AF65-F5344CB8AC3E}">
        <p14:creationId xmlns:p14="http://schemas.microsoft.com/office/powerpoint/2010/main" val="17073386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8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imothée Joye</dc:creator>
  <cp:lastModifiedBy>Timothée Joye</cp:lastModifiedBy>
  <cp:revision>2</cp:revision>
  <dcterms:created xsi:type="dcterms:W3CDTF">2022-04-26T09:01:44Z</dcterms:created>
  <dcterms:modified xsi:type="dcterms:W3CDTF">2022-04-26T16:31:26Z</dcterms:modified>
</cp:coreProperties>
</file>